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63" r:id="rId2"/>
  </p:sldIdLst>
  <p:sldSz cx="9144000" cy="6858000" type="screen4x3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Helle Formatvorlag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F5AB1C69-6EDB-4FF4-983F-18BD219EF322}" styleName="Mittlere Formatvorlage 2 - Akz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2D5ABB26-0587-4C30-8999-92F81FD0307C}" styleName="Keine Formatvorlage, kei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4" autoAdjust="0"/>
    <p:restoredTop sz="94660"/>
  </p:normalViewPr>
  <p:slideViewPr>
    <p:cSldViewPr snapToGrid="0">
      <p:cViewPr varScale="1">
        <p:scale>
          <a:sx n="113" d="100"/>
          <a:sy n="113" d="100"/>
        </p:scale>
        <p:origin x="-1596" y="-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8AF839-5C3E-4856-8A92-A2975081E69A}" type="datetimeFigureOut">
              <a:rPr lang="de-DE" smtClean="0"/>
              <a:t>16.02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668F08-4961-4A68-91E5-CAB68814603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881669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8AF839-5C3E-4856-8A92-A2975081E69A}" type="datetimeFigureOut">
              <a:rPr lang="de-DE" smtClean="0"/>
              <a:t>16.02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668F08-4961-4A68-91E5-CAB68814603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034417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8AF839-5C3E-4856-8A92-A2975081E69A}" type="datetimeFigureOut">
              <a:rPr lang="de-DE" smtClean="0"/>
              <a:t>16.02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668F08-4961-4A68-91E5-CAB68814603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236041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8AF839-5C3E-4856-8A92-A2975081E69A}" type="datetimeFigureOut">
              <a:rPr lang="de-DE" smtClean="0"/>
              <a:t>16.02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668F08-4961-4A68-91E5-CAB68814603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874658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8AF839-5C3E-4856-8A92-A2975081E69A}" type="datetimeFigureOut">
              <a:rPr lang="de-DE" smtClean="0"/>
              <a:t>16.02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668F08-4961-4A68-91E5-CAB68814603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77857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8AF839-5C3E-4856-8A92-A2975081E69A}" type="datetimeFigureOut">
              <a:rPr lang="de-DE" smtClean="0"/>
              <a:t>16.02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668F08-4961-4A68-91E5-CAB68814603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608524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8AF839-5C3E-4856-8A92-A2975081E69A}" type="datetimeFigureOut">
              <a:rPr lang="de-DE" smtClean="0"/>
              <a:t>16.02.2023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668F08-4961-4A68-91E5-CAB68814603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711377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8AF839-5C3E-4856-8A92-A2975081E69A}" type="datetimeFigureOut">
              <a:rPr lang="de-DE" smtClean="0"/>
              <a:t>16.02.2023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668F08-4961-4A68-91E5-CAB68814603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334146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8AF839-5C3E-4856-8A92-A2975081E69A}" type="datetimeFigureOut">
              <a:rPr lang="de-DE" smtClean="0"/>
              <a:t>16.02.2023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668F08-4961-4A68-91E5-CAB68814603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528363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8AF839-5C3E-4856-8A92-A2975081E69A}" type="datetimeFigureOut">
              <a:rPr lang="de-DE" smtClean="0"/>
              <a:t>16.02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668F08-4961-4A68-91E5-CAB68814603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665794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8AF839-5C3E-4856-8A92-A2975081E69A}" type="datetimeFigureOut">
              <a:rPr lang="de-DE" smtClean="0"/>
              <a:t>16.02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668F08-4961-4A68-91E5-CAB68814603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567709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8AF839-5C3E-4856-8A92-A2975081E69A}" type="datetimeFigureOut">
              <a:rPr lang="de-DE" smtClean="0"/>
              <a:t>16.02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668F08-4961-4A68-91E5-CAB68814603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752952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331546" y="393677"/>
            <a:ext cx="8505698" cy="2192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25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Table 1.</a:t>
            </a:r>
            <a:r>
              <a:rPr lang="en-US" sz="825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atient cohort of 17 </a:t>
            </a:r>
            <a:r>
              <a:rPr lang="de-AT" sz="825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n-Ewing sarcoma patients with </a:t>
            </a:r>
            <a:r>
              <a:rPr lang="en-US" sz="825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emotherapy </a:t>
            </a:r>
            <a:r>
              <a:rPr lang="en-US" sz="825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ssociated </a:t>
            </a:r>
            <a:r>
              <a:rPr lang="en-US" sz="825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utropenia</a:t>
            </a:r>
            <a:r>
              <a:rPr lang="de-AT" sz="825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de-DE" sz="825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Tabel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24476420"/>
              </p:ext>
            </p:extLst>
          </p:nvPr>
        </p:nvGraphicFramePr>
        <p:xfrm>
          <a:off x="427287" y="780974"/>
          <a:ext cx="7665679" cy="5030275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10235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473710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290737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  <a:gridCol w="1167448">
                  <a:extLst>
                    <a:ext uri="{9D8B030D-6E8A-4147-A177-3AD203B41FA5}">
                      <a16:colId xmlns="" xmlns:a16="http://schemas.microsoft.com/office/drawing/2014/main" val="20003"/>
                    </a:ext>
                  </a:extLst>
                </a:gridCol>
                <a:gridCol w="794385">
                  <a:extLst>
                    <a:ext uri="{9D8B030D-6E8A-4147-A177-3AD203B41FA5}">
                      <a16:colId xmlns="" xmlns:a16="http://schemas.microsoft.com/office/drawing/2014/main" val="20004"/>
                    </a:ext>
                  </a:extLst>
                </a:gridCol>
                <a:gridCol w="1218101">
                  <a:extLst>
                    <a:ext uri="{9D8B030D-6E8A-4147-A177-3AD203B41FA5}">
                      <a16:colId xmlns="" xmlns:a16="http://schemas.microsoft.com/office/drawing/2014/main" val="1300494767"/>
                    </a:ext>
                  </a:extLst>
                </a:gridCol>
                <a:gridCol w="525518">
                  <a:extLst>
                    <a:ext uri="{9D8B030D-6E8A-4147-A177-3AD203B41FA5}">
                      <a16:colId xmlns="" xmlns:a16="http://schemas.microsoft.com/office/drawing/2014/main" val="3597256934"/>
                    </a:ext>
                  </a:extLst>
                </a:gridCol>
                <a:gridCol w="704193">
                  <a:extLst>
                    <a:ext uri="{9D8B030D-6E8A-4147-A177-3AD203B41FA5}">
                      <a16:colId xmlns="" xmlns:a16="http://schemas.microsoft.com/office/drawing/2014/main" val="2415043446"/>
                    </a:ext>
                  </a:extLst>
                </a:gridCol>
                <a:gridCol w="690211">
                  <a:extLst>
                    <a:ext uri="{9D8B030D-6E8A-4147-A177-3AD203B41FA5}">
                      <a16:colId xmlns="" xmlns:a16="http://schemas.microsoft.com/office/drawing/2014/main" val="616369993"/>
                    </a:ext>
                  </a:extLst>
                </a:gridCol>
                <a:gridCol w="578069">
                  <a:extLst>
                    <a:ext uri="{9D8B030D-6E8A-4147-A177-3AD203B41FA5}">
                      <a16:colId xmlns="" xmlns:a16="http://schemas.microsoft.com/office/drawing/2014/main" val="2339599718"/>
                    </a:ext>
                  </a:extLst>
                </a:gridCol>
                <a:gridCol w="613072">
                  <a:extLst>
                    <a:ext uri="{9D8B030D-6E8A-4147-A177-3AD203B41FA5}">
                      <a16:colId xmlns="" xmlns:a16="http://schemas.microsoft.com/office/drawing/2014/main" val="3782258611"/>
                    </a:ext>
                  </a:extLst>
                </a:gridCol>
              </a:tblGrid>
              <a:tr h="263401"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Patient ID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Age</a:t>
                      </a:r>
                      <a:r>
                        <a:rPr lang="de-AT" sz="800" kern="1200" baseline="0" dirty="0" smtClean="0">
                          <a:solidFill>
                            <a:schemeClr val="tx1"/>
                          </a:solidFill>
                        </a:rPr>
                        <a:t> </a:t>
                      </a:r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[y</a:t>
                      </a:r>
                      <a:r>
                        <a:rPr lang="de-AT" sz="800" kern="1200" dirty="0">
                          <a:solidFill>
                            <a:schemeClr val="tx1"/>
                          </a:solidFill>
                        </a:rPr>
                        <a:t>]</a:t>
                      </a:r>
                      <a:endParaRPr lang="de-AT" sz="800" b="1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>
                          <a:solidFill>
                            <a:schemeClr val="tx1"/>
                          </a:solidFill>
                        </a:rPr>
                        <a:t>Sex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Tumor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Protocol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Chemotherapy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/>
                </a:tc>
                <a:tc gridSpan="3"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Nadir</a:t>
                      </a:r>
                      <a:endParaRPr lang="de-AT" sz="800" kern="1200" dirty="0">
                        <a:solidFill>
                          <a:schemeClr val="tx1"/>
                        </a:solidFill>
                      </a:endParaRPr>
                    </a:p>
                    <a:p>
                      <a:pPr marL="0" algn="ctr" defTabSz="685800" rtl="0" eaLnBrk="1" latinLnBrk="0" hangingPunct="1"/>
                      <a:r>
                        <a:rPr lang="en-US" sz="800" kern="1200" noProof="0" dirty="0" smtClean="0">
                          <a:solidFill>
                            <a:schemeClr val="tx1"/>
                          </a:solidFill>
                        </a:rPr>
                        <a:t>Neutrophils</a:t>
                      </a:r>
                      <a:r>
                        <a:rPr lang="en-US" sz="800" kern="1200" baseline="0" noProof="0" dirty="0" smtClean="0">
                          <a:solidFill>
                            <a:schemeClr val="tx1"/>
                          </a:solidFill>
                        </a:rPr>
                        <a:t>    Platelets        Reticulocytes</a:t>
                      </a:r>
                      <a:endParaRPr lang="en-US" sz="800" kern="1200" noProof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/>
                </a:tc>
                <a:tc hMerge="1">
                  <a:txBody>
                    <a:bodyPr/>
                    <a:lstStyle/>
                    <a:p>
                      <a:pPr marL="0" algn="ctr" defTabSz="685800" rtl="0" eaLnBrk="1" latinLnBrk="0" hangingPunct="1"/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 hMerge="1">
                  <a:txBody>
                    <a:bodyPr/>
                    <a:lstStyle/>
                    <a:p>
                      <a:pPr marL="0" algn="ctr" defTabSz="685800" rtl="0" eaLnBrk="1" latinLnBrk="0" hangingPunct="1"/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IPF </a:t>
                      </a:r>
                    </a:p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Peak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CRP</a:t>
                      </a:r>
                    </a:p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Peak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/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278351"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#12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5.75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>
                          <a:solidFill>
                            <a:schemeClr val="tx1"/>
                          </a:solidFill>
                        </a:rPr>
                        <a:t>m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neuroblastoma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LINES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CAR, DOX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 11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11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8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11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17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278351"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#13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0.84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>
                          <a:solidFill>
                            <a:schemeClr val="tx1"/>
                          </a:solidFill>
                        </a:rPr>
                        <a:t>f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rhabdomyosarcoma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CWS-2007-HR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IFO, VCR, ADR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10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12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11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13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16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278351"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#14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5.09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m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nephroblastoma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SIOP 2001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VCR, ACT-D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7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7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7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10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14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278351"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#15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1.0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>
                          <a:solidFill>
                            <a:schemeClr val="tx1"/>
                          </a:solidFill>
                        </a:rPr>
                        <a:t>m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neuroblastoma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HR-NBL-1.8</a:t>
                      </a:r>
                      <a:endParaRPr lang="de-AT" sz="800" kern="12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ETO, VCR,</a:t>
                      </a:r>
                      <a:r>
                        <a:rPr lang="de-AT" sz="800" kern="1200" baseline="0" dirty="0" smtClean="0">
                          <a:solidFill>
                            <a:schemeClr val="tx1"/>
                          </a:solidFill>
                        </a:rPr>
                        <a:t> CYC</a:t>
                      </a:r>
                      <a:endParaRPr lang="de-AT" sz="800" kern="12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5</a:t>
                      </a:r>
                      <a:endParaRPr lang="de-AT" sz="800" kern="12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8</a:t>
                      </a:r>
                      <a:endParaRPr lang="de-AT" sz="800" kern="12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5</a:t>
                      </a:r>
                      <a:endParaRPr lang="de-AT" sz="800" kern="12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3</a:t>
                      </a:r>
                      <a:endParaRPr lang="de-AT" sz="800" kern="12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9</a:t>
                      </a:r>
                      <a:endParaRPr lang="de-AT" sz="800" kern="12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  <a:tr h="278351"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#16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0.01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m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retinoblastoma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---*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ETO, CYC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8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8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5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8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8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="" xmlns:a16="http://schemas.microsoft.com/office/drawing/2014/main" val="10005"/>
                  </a:ext>
                </a:extLst>
              </a:tr>
              <a:tr h="264239"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#17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3.0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>
                          <a:solidFill>
                            <a:schemeClr val="tx1"/>
                          </a:solidFill>
                        </a:rPr>
                        <a:t>f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nephroblastoma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SIOP 2001</a:t>
                      </a:r>
                      <a:endParaRPr lang="de-AT" sz="800" kern="12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IFO, CYC,</a:t>
                      </a:r>
                      <a:r>
                        <a:rPr lang="de-AT" sz="800" kern="1200" baseline="0" dirty="0" smtClean="0">
                          <a:solidFill>
                            <a:schemeClr val="tx1"/>
                          </a:solidFill>
                        </a:rPr>
                        <a:t> ETO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12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12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5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12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13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="" xmlns:a16="http://schemas.microsoft.com/office/drawing/2014/main" val="10006"/>
                  </a:ext>
                </a:extLst>
              </a:tr>
              <a:tr h="278351"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#18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>
                          <a:solidFill>
                            <a:schemeClr val="tx1"/>
                          </a:solidFill>
                        </a:rPr>
                        <a:t>16.08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>
                          <a:solidFill>
                            <a:schemeClr val="tx1"/>
                          </a:solidFill>
                        </a:rPr>
                        <a:t>m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germinoma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MAKEI 96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CAR, ETO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15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13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7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13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15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="" xmlns:a16="http://schemas.microsoft.com/office/drawing/2014/main" val="10007"/>
                  </a:ext>
                </a:extLst>
              </a:tr>
              <a:tr h="278351"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#19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9.09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>
                          <a:solidFill>
                            <a:schemeClr val="tx1"/>
                          </a:solidFill>
                        </a:rPr>
                        <a:t>f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myoepithelial</a:t>
                      </a:r>
                      <a:r>
                        <a:rPr lang="de-AT" sz="800" kern="1200" baseline="0" dirty="0" smtClean="0">
                          <a:solidFill>
                            <a:schemeClr val="tx1"/>
                          </a:solidFill>
                        </a:rPr>
                        <a:t> carcinoma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---*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CAR,</a:t>
                      </a:r>
                      <a:r>
                        <a:rPr lang="de-AT" sz="800" kern="1200" baseline="0" dirty="0" smtClean="0">
                          <a:solidFill>
                            <a:schemeClr val="tx1"/>
                          </a:solidFill>
                        </a:rPr>
                        <a:t> ETO, IFO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13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12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4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6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6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="" xmlns:a16="http://schemas.microsoft.com/office/drawing/2014/main" val="10008"/>
                  </a:ext>
                </a:extLst>
              </a:tr>
              <a:tr h="278351"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#20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4.92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>
                          <a:solidFill>
                            <a:schemeClr val="tx1"/>
                          </a:solidFill>
                        </a:rPr>
                        <a:t>m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neuroblastoma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HR-NBL-1.8</a:t>
                      </a:r>
                      <a:endParaRPr lang="de-AT" sz="800" kern="12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ETO, VCR,</a:t>
                      </a:r>
                      <a:r>
                        <a:rPr lang="de-AT" sz="800" kern="1200" baseline="0" dirty="0" smtClean="0">
                          <a:solidFill>
                            <a:schemeClr val="tx1"/>
                          </a:solidFill>
                        </a:rPr>
                        <a:t> CYC</a:t>
                      </a:r>
                      <a:endParaRPr lang="de-AT" sz="800" kern="12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13</a:t>
                      </a:r>
                      <a:endParaRPr lang="de-AT" sz="800" kern="12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2</a:t>
                      </a:r>
                      <a:endParaRPr lang="de-AT" sz="800" kern="12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7</a:t>
                      </a:r>
                      <a:endParaRPr lang="de-AT" sz="800" kern="12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8</a:t>
                      </a:r>
                      <a:endParaRPr lang="de-AT" sz="800" kern="12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9</a:t>
                      </a:r>
                      <a:endParaRPr lang="de-AT" sz="800" kern="12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="" xmlns:a16="http://schemas.microsoft.com/office/drawing/2014/main" val="10009"/>
                  </a:ext>
                </a:extLst>
              </a:tr>
              <a:tr h="278351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#21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12.92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m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hepatoblastoma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SIOPEL-3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CAR, DOX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11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15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7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11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15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="" xmlns:a16="http://schemas.microsoft.com/office/drawing/2014/main" val="88325993"/>
                  </a:ext>
                </a:extLst>
              </a:tr>
              <a:tr h="278351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#22</a:t>
                      </a:r>
                      <a:endParaRPr lang="de-AT" sz="800" kern="12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1.92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m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hepatoblastoma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SIOPEL-4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CAR, DOX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6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7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3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7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8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="" xmlns:a16="http://schemas.microsoft.com/office/drawing/2014/main" val="2166481016"/>
                  </a:ext>
                </a:extLst>
              </a:tr>
              <a:tr h="278351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#23</a:t>
                      </a:r>
                      <a:endParaRPr lang="de-AT" sz="800" kern="12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4.75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m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ependymoma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HIT-2000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CYC, VCR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13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12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9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12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12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="" xmlns:a16="http://schemas.microsoft.com/office/drawing/2014/main" val="2230926625"/>
                  </a:ext>
                </a:extLst>
              </a:tr>
              <a:tr h="278351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#24</a:t>
                      </a:r>
                      <a:endParaRPr lang="de-AT" sz="800" kern="12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0.84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m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rhabdomyosarcoma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CWS-2007-HR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IFO, VCR, ADR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6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4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3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4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3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="" xmlns:a16="http://schemas.microsoft.com/office/drawing/2014/main" val="3994256345"/>
                  </a:ext>
                </a:extLst>
              </a:tr>
              <a:tr h="278351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#25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1.17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f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rhabdoid tumor</a:t>
                      </a:r>
                      <a:endParaRPr lang="de-AT" sz="800" kern="12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---*</a:t>
                      </a:r>
                      <a:endParaRPr lang="de-AT" sz="800" kern="12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MTX,</a:t>
                      </a:r>
                      <a:r>
                        <a:rPr lang="de-AT" sz="800" kern="1200" baseline="0" dirty="0" smtClean="0">
                          <a:solidFill>
                            <a:schemeClr val="tx1"/>
                          </a:solidFill>
                        </a:rPr>
                        <a:t> ETO, VCR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11</a:t>
                      </a:r>
                      <a:endParaRPr lang="de-AT" sz="800" kern="12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12</a:t>
                      </a:r>
                      <a:endParaRPr lang="de-AT" sz="800" kern="12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7</a:t>
                      </a:r>
                      <a:endParaRPr lang="de-AT" sz="800" kern="12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10</a:t>
                      </a:r>
                      <a:endParaRPr lang="de-AT" sz="800" kern="12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15</a:t>
                      </a:r>
                      <a:endParaRPr lang="de-AT" sz="800" kern="12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="" xmlns:a16="http://schemas.microsoft.com/office/drawing/2014/main" val="3954888703"/>
                  </a:ext>
                </a:extLst>
              </a:tr>
              <a:tr h="278351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#26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4.92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f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rhabdomyosarcoma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CWS-2007-SR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IFO, VCR, ADR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10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9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7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10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7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="" xmlns:a16="http://schemas.microsoft.com/office/drawing/2014/main" val="3138710315"/>
                  </a:ext>
                </a:extLst>
              </a:tr>
              <a:tr h="278351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#27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6.67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f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nephroblastoma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SIOP 2001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IFO, CYC,</a:t>
                      </a:r>
                      <a:r>
                        <a:rPr lang="de-AT" sz="800" kern="1200" baseline="0" dirty="0" smtClean="0">
                          <a:solidFill>
                            <a:schemeClr val="tx1"/>
                          </a:solidFill>
                        </a:rPr>
                        <a:t> ETO</a:t>
                      </a:r>
                      <a:endParaRPr lang="de-AT" sz="800" kern="12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11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15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7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10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11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="" xmlns:a16="http://schemas.microsoft.com/office/drawing/2014/main" val="205992996"/>
                  </a:ext>
                </a:extLst>
              </a:tr>
              <a:tr h="278351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#28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0.25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f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xanthogranulomatosis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---*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VCR, IFO, DOX,</a:t>
                      </a:r>
                      <a:r>
                        <a:rPr lang="de-AT" sz="800" kern="1200" baseline="0" dirty="0" smtClean="0">
                          <a:solidFill>
                            <a:schemeClr val="tx1"/>
                          </a:solidFill>
                        </a:rPr>
                        <a:t> ETO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9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11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4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10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AT" sz="800" kern="1200" dirty="0" smtClean="0">
                          <a:solidFill>
                            <a:schemeClr val="tx1"/>
                          </a:solidFill>
                        </a:rPr>
                        <a:t>+10</a:t>
                      </a:r>
                      <a:endParaRPr lang="de-AT" sz="8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="" xmlns:a16="http://schemas.microsoft.com/office/drawing/2014/main" val="3403107884"/>
                  </a:ext>
                </a:extLst>
              </a:tr>
            </a:tbl>
          </a:graphicData>
        </a:graphic>
      </p:graphicFrame>
      <p:sp>
        <p:nvSpPr>
          <p:cNvPr id="3" name="Textfeld 2"/>
          <p:cNvSpPr txBox="1"/>
          <p:nvPr/>
        </p:nvSpPr>
        <p:spPr>
          <a:xfrm>
            <a:off x="331546" y="5927970"/>
            <a:ext cx="8417753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825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--*: </a:t>
            </a:r>
            <a:r>
              <a:rPr lang="en-US" sz="825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eatment was based upon recent publications.</a:t>
            </a:r>
          </a:p>
          <a:p>
            <a:r>
              <a:rPr lang="de-AT" sz="825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R: Carboplatin; DOX: Doxorubicin; IFO: Ifosfamide; VCR: Vincristine; ADR: Adriamycin</a:t>
            </a:r>
            <a:r>
              <a:rPr lang="de-AT" sz="825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ACT-D: Actinomycin; </a:t>
            </a:r>
            <a:r>
              <a:rPr lang="de-AT" sz="825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TO: </a:t>
            </a:r>
            <a:r>
              <a:rPr lang="de-AT" sz="825" dirty="0">
                <a:latin typeface="Times New Roman" panose="02020603050405020304" pitchFamily="18" charset="0"/>
                <a:cs typeface="Times New Roman" panose="02020603050405020304" pitchFamily="18" charset="0"/>
              </a:rPr>
              <a:t>Etoposide, </a:t>
            </a:r>
            <a:r>
              <a:rPr lang="de-AT" sz="825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YC: Cyclophosphamide; MTX: Methotrexate.</a:t>
            </a:r>
            <a:endParaRPr lang="de-DE" sz="825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789973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29</Words>
  <Application>Microsoft Office PowerPoint</Application>
  <PresentationFormat>Bildschirmpräsentation (4:3)</PresentationFormat>
  <Paragraphs>202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Office</vt:lpstr>
      <vt:lpstr>PowerPoint-Präsentation</vt:lpstr>
    </vt:vector>
  </TitlesOfParts>
  <Company>tirol-klinike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ERYK Andreas</dc:creator>
  <cp:lastModifiedBy>Niederwanger</cp:lastModifiedBy>
  <cp:revision>75</cp:revision>
  <cp:lastPrinted>2023-02-10T13:24:53Z</cp:lastPrinted>
  <dcterms:created xsi:type="dcterms:W3CDTF">2021-10-22T13:21:34Z</dcterms:created>
  <dcterms:modified xsi:type="dcterms:W3CDTF">2023-02-16T06:44:50Z</dcterms:modified>
</cp:coreProperties>
</file>